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AB1F36-C981-41DC-976D-A6DD086D1A36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4BD0CD-F4C0-458C-89F0-599CD7688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755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167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199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709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492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086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063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322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33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440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610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560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241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28600"/>
            <a:ext cx="7848600" cy="381000"/>
          </a:xfrm>
        </p:spPr>
        <p:txBody>
          <a:bodyPr>
            <a:normAutofit/>
          </a:bodyPr>
          <a:lstStyle/>
          <a:p>
            <a:pPr algn="l"/>
            <a:r>
              <a:rPr lang="en-US" sz="1400" b="1" dirty="0"/>
              <a:t>Supplemental Table 2</a:t>
            </a:r>
            <a:r>
              <a:rPr lang="en-US" sz="1400" dirty="0"/>
              <a:t>. Thyroglobulin and Thyroglobulin Antibody Methodologies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894034"/>
              </p:ext>
            </p:extLst>
          </p:nvPr>
        </p:nvGraphicFramePr>
        <p:xfrm>
          <a:off x="685800" y="609600"/>
          <a:ext cx="7620000" cy="317357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57176"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yroglobuli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45" marR="8645" marT="864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1771">
                <a:tc>
                  <a:txBody>
                    <a:bodyPr/>
                    <a:lstStyle/>
                    <a:p>
                      <a:pPr algn="l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A (in-house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A (send-out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A (send-out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C MS/MS (send-out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6366">
                <a:tc>
                  <a:txBody>
                    <a:bodyPr/>
                    <a:lstStyle/>
                    <a:p>
                      <a:pPr algn="l" fontAlgn="ctr"/>
                      <a:endParaRPr lang="en-US" sz="100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stem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Cel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xI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8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Cel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xI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8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ioimmunoassa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C MS/M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63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ufactur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ckman Coult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ckman Coult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boratory Developed Tes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boratory Developed Tes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55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odolog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multaneous one-step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enzymati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say</a:t>
                      </a:r>
                      <a:r>
                        <a:rPr lang="en-US" sz="1000" u="none" strike="noStrike" baseline="30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multaneous one-step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enzymati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ssa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ioimmunoassa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o dimensional LC MS/M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11771"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ceability</a:t>
                      </a: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M 457</a:t>
                      </a:r>
                      <a:r>
                        <a:rPr lang="en-US" sz="10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M 457</a:t>
                      </a:r>
                      <a:r>
                        <a:rPr lang="en-US" sz="10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M 457</a:t>
                      </a:r>
                      <a:r>
                        <a:rPr lang="en-US" sz="10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M 457</a:t>
                      </a:r>
                      <a:r>
                        <a:rPr lang="en-US" sz="10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11771">
                <a:tc>
                  <a:txBody>
                    <a:bodyPr/>
                    <a:lstStyle/>
                    <a:p>
                      <a:pPr algn="l" fontAlgn="ctr"/>
                      <a:endParaRPr lang="en-US" sz="100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nctional</a:t>
                      </a:r>
                      <a:r>
                        <a:rPr lang="en-US" sz="1000" u="none" strike="noStrike" baseline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ensitivit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 ng/m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 ng/m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ng/m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 ng/m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11771">
                <a:tc>
                  <a:txBody>
                    <a:bodyPr/>
                    <a:lstStyle/>
                    <a:p>
                      <a:pPr algn="l" fontAlgn="ctr"/>
                      <a:endParaRPr lang="en-US" sz="100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rn around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</a:t>
                      </a:r>
                      <a:r>
                        <a:rPr lang="en-US" sz="1000" u="none" strike="noStrike" baseline="30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ur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s to week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57176">
                <a:tc>
                  <a:txBody>
                    <a:bodyPr/>
                    <a:lstStyle/>
                    <a:p>
                      <a:pPr algn="l" fontAlgn="ctr"/>
                      <a:endParaRPr lang="en-US" sz="100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omatio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57176">
                <a:tc>
                  <a:txBody>
                    <a:bodyPr/>
                    <a:lstStyle/>
                    <a:p>
                      <a:pPr algn="l" fontAlgn="ctr"/>
                      <a:endParaRPr lang="en-US" sz="100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ioactivit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11771">
                <a:tc>
                  <a:txBody>
                    <a:bodyPr/>
                    <a:lstStyle/>
                    <a:p>
                      <a:pPr algn="l" fontAlgn="ctr"/>
                      <a:endParaRPr lang="en-US" sz="100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ctr"/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tibody interferenc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 susceptibl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 susceptibl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ss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sceptible</a:t>
                      </a:r>
                      <a:r>
                        <a:rPr lang="en-US" sz="1000" u="none" strike="noStrike" baseline="30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0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45" marR="8645" marT="864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09600" y="6096000"/>
            <a:ext cx="586740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uropean Community Bureau of Reference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ampl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ollection to lab result reporting</a:t>
            </a:r>
          </a:p>
          <a:p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pencer CA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(2005) </a:t>
            </a:r>
            <a:r>
              <a:rPr lang="it-IT" sz="1000" i="1" dirty="0">
                <a:latin typeface="Arial" panose="020B0604020202020204" pitchFamily="34" charset="0"/>
                <a:cs typeface="Arial" panose="020B0604020202020204" pitchFamily="34" charset="0"/>
              </a:rPr>
              <a:t>J Clin Endocrinol Metab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90: 5566–5575</a:t>
            </a:r>
          </a:p>
          <a:p>
            <a:r>
              <a:rPr lang="it-IT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ckman Coulter Access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hyroglob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#33860 </a:t>
            </a:r>
            <a:endParaRPr 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6161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6</TotalTime>
  <Words>145</Words>
  <Application>Microsoft Office PowerPoint</Application>
  <PresentationFormat>On-screen Show (4:3)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Supplemental Table 2. Thyroglobulin and Thyroglobulin Antibody Methodologi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Work</dc:creator>
  <cp:lastModifiedBy>Wheeler, Sarah</cp:lastModifiedBy>
  <cp:revision>22</cp:revision>
  <dcterms:created xsi:type="dcterms:W3CDTF">2014-07-31T18:58:44Z</dcterms:created>
  <dcterms:modified xsi:type="dcterms:W3CDTF">2017-12-06T22:21:20Z</dcterms:modified>
</cp:coreProperties>
</file>